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0" autoAdjust="0"/>
    <p:restoredTop sz="94660"/>
  </p:normalViewPr>
  <p:slideViewPr>
    <p:cSldViewPr snapToGrid="0">
      <p:cViewPr varScale="1">
        <p:scale>
          <a:sx n="78" d="100"/>
          <a:sy n="78" d="100"/>
        </p:scale>
        <p:origin x="64" y="3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2A0EE-7D56-4840-9482-360A0F86B3C4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FEEA-3FA1-450C-9729-82EDECD04B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128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2A0EE-7D56-4840-9482-360A0F86B3C4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FEEA-3FA1-450C-9729-82EDECD04B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2531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2A0EE-7D56-4840-9482-360A0F86B3C4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FEEA-3FA1-450C-9729-82EDECD04B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324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2A0EE-7D56-4840-9482-360A0F86B3C4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FEEA-3FA1-450C-9729-82EDECD04B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7138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2A0EE-7D56-4840-9482-360A0F86B3C4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FEEA-3FA1-450C-9729-82EDECD04B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1737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2A0EE-7D56-4840-9482-360A0F86B3C4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FEEA-3FA1-450C-9729-82EDECD04B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4726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2A0EE-7D56-4840-9482-360A0F86B3C4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FEEA-3FA1-450C-9729-82EDECD04B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7724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2A0EE-7D56-4840-9482-360A0F86B3C4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FEEA-3FA1-450C-9729-82EDECD04B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0013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2A0EE-7D56-4840-9482-360A0F86B3C4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FEEA-3FA1-450C-9729-82EDECD04B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99200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2A0EE-7D56-4840-9482-360A0F86B3C4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FEEA-3FA1-450C-9729-82EDECD04B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8083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82A0EE-7D56-4840-9482-360A0F86B3C4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EDFEEA-3FA1-450C-9729-82EDECD04B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3823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82A0EE-7D56-4840-9482-360A0F86B3C4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EDFEEA-3FA1-450C-9729-82EDECD04B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24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200" y="177800"/>
            <a:ext cx="9753600" cy="6502400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285750" y="177800"/>
            <a:ext cx="351064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Legend: Raw </a:t>
            </a:r>
            <a:r>
              <a:rPr lang="en-US" altLang="ja-JP" dirty="0"/>
              <a:t>SDS-PAGE gel data from Figure 1 figure supplement 1 A: the </a:t>
            </a:r>
            <a:r>
              <a:rPr lang="en-US" altLang="ja-JP"/>
              <a:t>original </a:t>
            </a:r>
            <a:r>
              <a:rPr lang="en-US" altLang="ja-JP" smtClean="0"/>
              <a:t>image </a:t>
            </a:r>
            <a:r>
              <a:rPr lang="en-US" altLang="ja-JP" dirty="0"/>
              <a:t>of the full raw unedited gel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786634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200" y="177800"/>
            <a:ext cx="9753600" cy="6502400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E7786363-0040-DD4F-ACFF-3036B27CED4F}"/>
              </a:ext>
            </a:extLst>
          </p:cNvPr>
          <p:cNvSpPr/>
          <p:nvPr/>
        </p:nvSpPr>
        <p:spPr>
          <a:xfrm>
            <a:off x="4661807" y="1122362"/>
            <a:ext cx="1477737" cy="5557837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/>
          <p:cNvSpPr/>
          <p:nvPr/>
        </p:nvSpPr>
        <p:spPr>
          <a:xfrm rot="18021029">
            <a:off x="5130773" y="539979"/>
            <a:ext cx="68466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 smtClean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H-Tau</a:t>
            </a:r>
            <a:endParaRPr lang="en-US" altLang="ja-JP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 rot="18021029">
            <a:off x="5693706" y="304565"/>
            <a:ext cx="110131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 smtClean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el-MTBD h-Tau</a:t>
            </a:r>
            <a:endParaRPr lang="en-US" altLang="ja-JP" sz="1200" b="1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AD890EE-471F-484A-83F3-7A083B8DA78B}"/>
              </a:ext>
            </a:extLst>
          </p:cNvPr>
          <p:cNvSpPr txBox="1"/>
          <p:nvPr/>
        </p:nvSpPr>
        <p:spPr>
          <a:xfrm>
            <a:off x="6139544" y="6115834"/>
            <a:ext cx="23487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 figure supplement 1</a:t>
            </a:r>
            <a:endParaRPr kumimoji="1" lang="ja-JP" altLang="en-US" sz="1600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85750" y="177800"/>
            <a:ext cx="351064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/>
              <a:t>Legend: Raw </a:t>
            </a:r>
            <a:r>
              <a:rPr lang="en-US" altLang="ja-JP" dirty="0"/>
              <a:t>SDS-PAGE gel data from Figure 1 figure supplement 1 A: </a:t>
            </a:r>
            <a:r>
              <a:rPr lang="en-US" altLang="ja-JP" dirty="0" smtClean="0"/>
              <a:t>gel image </a:t>
            </a:r>
            <a:r>
              <a:rPr lang="en-US" altLang="ja-JP" dirty="0"/>
              <a:t>with </a:t>
            </a:r>
            <a:r>
              <a:rPr lang="en-US" altLang="ja-JP" dirty="0" smtClean="0"/>
              <a:t>information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40655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50</Words>
  <Application>Microsoft Office PowerPoint</Application>
  <PresentationFormat>ワイド画面</PresentationFormat>
  <Paragraphs>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ＭＳ ゴシック</vt:lpstr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etsuya.hori.1970@gmail.com</dc:creator>
  <cp:lastModifiedBy>tetsuya.hori.1970@gmail.com</cp:lastModifiedBy>
  <cp:revision>3</cp:revision>
  <dcterms:created xsi:type="dcterms:W3CDTF">2021-09-08T07:11:39Z</dcterms:created>
  <dcterms:modified xsi:type="dcterms:W3CDTF">2022-04-05T06:52:01Z</dcterms:modified>
</cp:coreProperties>
</file>